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1" r:id="rId2"/>
  </p:sldIdLst>
  <p:sldSz cx="1471295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41"/>
    <p:restoredTop sz="94860"/>
  </p:normalViewPr>
  <p:slideViewPr>
    <p:cSldViewPr snapToGrid="0">
      <p:cViewPr varScale="1">
        <p:scale>
          <a:sx n="100" d="100"/>
          <a:sy n="100" d="100"/>
        </p:scale>
        <p:origin x="3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441197-92B1-4646-BA55-8239BBC6546A}" type="datetimeFigureOut">
              <a:rPr lang="en-US" smtClean="0"/>
              <a:t>2/1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063" y="1143000"/>
            <a:ext cx="6619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4C7BAB-B477-034F-9496-6E0B4466C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839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4C7BAB-B477-034F-9496-6E0B4466C22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034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39119" y="1122363"/>
            <a:ext cx="11034713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39119" y="3602038"/>
            <a:ext cx="11034713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319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535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528955" y="365125"/>
            <a:ext cx="317248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11515" y="365125"/>
            <a:ext cx="9333528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142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392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3853" y="1709739"/>
            <a:ext cx="12689919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3853" y="4589464"/>
            <a:ext cx="12689919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793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11515" y="1825625"/>
            <a:ext cx="6253004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48431" y="1825625"/>
            <a:ext cx="6253004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499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432" y="365126"/>
            <a:ext cx="12689919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3432" y="1681163"/>
            <a:ext cx="622426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13432" y="2505075"/>
            <a:ext cx="622426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48431" y="1681163"/>
            <a:ext cx="625492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48431" y="2505075"/>
            <a:ext cx="625492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042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027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520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432" y="457200"/>
            <a:ext cx="474530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54920" y="987426"/>
            <a:ext cx="744843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3432" y="2057400"/>
            <a:ext cx="474530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773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432" y="457200"/>
            <a:ext cx="474530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54920" y="987426"/>
            <a:ext cx="744843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3432" y="2057400"/>
            <a:ext cx="474530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464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11516" y="365126"/>
            <a:ext cx="12689919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1516" y="1825625"/>
            <a:ext cx="12689919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11515" y="6356351"/>
            <a:ext cx="331041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B2993E-F847-F948-B056-36E6558F97AD}" type="datetimeFigureOut">
              <a:rPr lang="en-US" smtClean="0"/>
              <a:t>2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73665" y="6356351"/>
            <a:ext cx="496562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91021" y="6356351"/>
            <a:ext cx="331041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9928C1-5DE4-9C46-AAB3-C3B071ECF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69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60E460E-00B0-FB23-4E81-9E9E1D76D8F9}"/>
              </a:ext>
            </a:extLst>
          </p:cNvPr>
          <p:cNvGrpSpPr/>
          <p:nvPr/>
        </p:nvGrpSpPr>
        <p:grpSpPr>
          <a:xfrm>
            <a:off x="3369377" y="98328"/>
            <a:ext cx="7668737" cy="6722829"/>
            <a:chOff x="3369377" y="98328"/>
            <a:chExt cx="7668737" cy="6722829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412FA2D-B17B-CEA9-A8A9-B1AE9E9BF07D}"/>
                </a:ext>
              </a:extLst>
            </p:cNvPr>
            <p:cNvSpPr txBox="1"/>
            <p:nvPr/>
          </p:nvSpPr>
          <p:spPr>
            <a:xfrm>
              <a:off x="3369377" y="6359492"/>
              <a:ext cx="766371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: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TROBE Flow Diagram Outlining Participant Inclusion and Exclusion Steps at Each Stage of Data Analysis.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9970FF79-5A40-D4B8-4C67-D18907C67A47}"/>
                </a:ext>
              </a:extLst>
            </p:cNvPr>
            <p:cNvSpPr/>
            <p:nvPr/>
          </p:nvSpPr>
          <p:spPr>
            <a:xfrm>
              <a:off x="6302439" y="98328"/>
              <a:ext cx="2173948" cy="4797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ssessed for eligibility (n=497)</a:t>
              </a:r>
            </a:p>
            <a:p>
              <a:pPr algn="ctr"/>
              <a:endParaRPr lang="en-US" sz="8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tire AID Metastatic Melanoma Database</a:t>
              </a:r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B6B42966-4274-D0D1-8996-5BEA3D6FDF77}"/>
                </a:ext>
              </a:extLst>
            </p:cNvPr>
            <p:cNvCxnSpPr>
              <a:cxnSpLocks/>
              <a:stCxn id="4" idx="2"/>
              <a:endCxn id="85" idx="0"/>
            </p:cNvCxnSpPr>
            <p:nvPr/>
          </p:nvCxnSpPr>
          <p:spPr>
            <a:xfrm flipH="1">
              <a:off x="7389413" y="578037"/>
              <a:ext cx="1" cy="92863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A67C28A8-EE0B-8DC5-A4D9-AD10010CA850}"/>
                </a:ext>
              </a:extLst>
            </p:cNvPr>
            <p:cNvSpPr/>
            <p:nvPr/>
          </p:nvSpPr>
          <p:spPr>
            <a:xfrm>
              <a:off x="6300764" y="3348813"/>
              <a:ext cx="2173948" cy="81247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documented imaging response receiving either 1L single anti-PD1 (n=167) </a:t>
              </a:r>
            </a:p>
            <a:p>
              <a:pPr algn="ctr"/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r combination anti-PD1 plus anti-CTLA4 (n=88) therapy</a:t>
              </a:r>
            </a:p>
            <a:p>
              <a:pPr algn="ctr"/>
              <a:endParaRPr lang="en-US" sz="8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n=255)</a:t>
              </a: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E4AA7894-0C9A-BC8A-5524-554A5FB21C3F}"/>
                </a:ext>
              </a:extLst>
            </p:cNvPr>
            <p:cNvCxnSpPr>
              <a:cxnSpLocks/>
              <a:endCxn id="19" idx="1"/>
            </p:cNvCxnSpPr>
            <p:nvPr/>
          </p:nvCxnSpPr>
          <p:spPr>
            <a:xfrm>
              <a:off x="7398066" y="1043119"/>
              <a:ext cx="695179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C37DBA02-EF1F-D7BB-50FE-6C743826E929}"/>
                </a:ext>
              </a:extLst>
            </p:cNvPr>
            <p:cNvSpPr/>
            <p:nvPr/>
          </p:nvSpPr>
          <p:spPr>
            <a:xfrm>
              <a:off x="8093245" y="664480"/>
              <a:ext cx="2944869" cy="75727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ed (n=181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that did not receive 1L therapy with single anti-PD1 or combination anti-PD1 plus anti-CTLA4 (n=148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uveal primary site (n=33)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537D6029-6532-6C0D-301D-24DA707844CD}"/>
                </a:ext>
              </a:extLst>
            </p:cNvPr>
            <p:cNvSpPr/>
            <p:nvPr/>
          </p:nvSpPr>
          <p:spPr>
            <a:xfrm>
              <a:off x="7464059" y="5101437"/>
              <a:ext cx="2574161" cy="11838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 Analysis (n=198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 anti-PD1 (n=124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ination anti-PD1 plus anti-CTLA4 (n=74)</a:t>
              </a:r>
            </a:p>
            <a:p>
              <a:endParaRPr lang="en-US" sz="8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to Next Treatment Analysis (n= 198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 anti-PD1 (n=124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ination anti-PD1 plus anti-CTLA4 (n=74)</a:t>
              </a: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1148795F-11D9-7189-474E-A50135556276}"/>
                </a:ext>
              </a:extLst>
            </p:cNvPr>
            <p:cNvSpPr/>
            <p:nvPr/>
          </p:nvSpPr>
          <p:spPr>
            <a:xfrm>
              <a:off x="4876575" y="5101433"/>
              <a:ext cx="2447056" cy="11785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linical Characteristics and Objective Imaging Response Analysis (n=198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 anti-PD1 (n=124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mbination anti-PD1 plus anti-CTLA4 (n=74)</a:t>
              </a:r>
            </a:p>
          </p:txBody>
        </p:sp>
        <p:cxnSp>
          <p:nvCxnSpPr>
            <p:cNvPr id="41" name="Elbow Connector 40">
              <a:extLst>
                <a:ext uri="{FF2B5EF4-FFF2-40B4-BE49-F238E27FC236}">
                  <a16:creationId xmlns:a16="http://schemas.microsoft.com/office/drawing/2014/main" id="{7AF39587-155E-B7B3-1C1A-EFA749B0F2F6}"/>
                </a:ext>
              </a:extLst>
            </p:cNvPr>
            <p:cNvCxnSpPr>
              <a:cxnSpLocks/>
              <a:stCxn id="13" idx="2"/>
              <a:endCxn id="32" idx="0"/>
            </p:cNvCxnSpPr>
            <p:nvPr/>
          </p:nvCxnSpPr>
          <p:spPr>
            <a:xfrm rot="5400000">
              <a:off x="6273850" y="3987545"/>
              <a:ext cx="940142" cy="1287635"/>
            </a:xfrm>
            <a:prstGeom prst="bentConnector3">
              <a:avLst>
                <a:gd name="adj1" fmla="val 50000"/>
              </a:avLst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Elbow Connector 49">
              <a:extLst>
                <a:ext uri="{FF2B5EF4-FFF2-40B4-BE49-F238E27FC236}">
                  <a16:creationId xmlns:a16="http://schemas.microsoft.com/office/drawing/2014/main" id="{13928D17-8C0F-852A-3443-789160673C5B}"/>
                </a:ext>
              </a:extLst>
            </p:cNvPr>
            <p:cNvCxnSpPr>
              <a:cxnSpLocks/>
              <a:stCxn id="13" idx="2"/>
              <a:endCxn id="29" idx="0"/>
            </p:cNvCxnSpPr>
            <p:nvPr/>
          </p:nvCxnSpPr>
          <p:spPr>
            <a:xfrm rot="16200000" flipH="1">
              <a:off x="7599366" y="3949663"/>
              <a:ext cx="940146" cy="1363402"/>
            </a:xfrm>
            <a:prstGeom prst="bentConnector3">
              <a:avLst>
                <a:gd name="adj1" fmla="val 50000"/>
              </a:avLst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A375FEC1-7C7B-AFB0-7EF8-87667150A23E}"/>
                </a:ext>
              </a:extLst>
            </p:cNvPr>
            <p:cNvSpPr/>
            <p:nvPr/>
          </p:nvSpPr>
          <p:spPr>
            <a:xfrm>
              <a:off x="8093245" y="4245293"/>
              <a:ext cx="2939847" cy="3003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ed (n=57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missing clinicodemographic variables (n=57)</a:t>
              </a: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EED9E3AD-7F7F-73D9-CD88-598496C4AC56}"/>
                </a:ext>
              </a:extLst>
            </p:cNvPr>
            <p:cNvCxnSpPr>
              <a:cxnSpLocks/>
            </p:cNvCxnSpPr>
            <p:nvPr/>
          </p:nvCxnSpPr>
          <p:spPr>
            <a:xfrm>
              <a:off x="7398066" y="4398900"/>
              <a:ext cx="69517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C3016091-61E0-FACD-3CA0-E313D797FAEC}"/>
                </a:ext>
              </a:extLst>
            </p:cNvPr>
            <p:cNvSpPr/>
            <p:nvPr/>
          </p:nvSpPr>
          <p:spPr>
            <a:xfrm>
              <a:off x="6302439" y="1506673"/>
              <a:ext cx="2173948" cy="100125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receiving either 1L single anti-PD1 (n=209) or combination anti-PD1 plus anti-CTLA4 (n=107) therapy.</a:t>
              </a:r>
            </a:p>
            <a:p>
              <a:pPr algn="ctr"/>
              <a:endParaRPr lang="en-US" sz="8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n=316)</a:t>
              </a:r>
            </a:p>
          </p:txBody>
        </p:sp>
        <p:cxnSp>
          <p:nvCxnSpPr>
            <p:cNvPr id="90" name="Straight Arrow Connector 89">
              <a:extLst>
                <a:ext uri="{FF2B5EF4-FFF2-40B4-BE49-F238E27FC236}">
                  <a16:creationId xmlns:a16="http://schemas.microsoft.com/office/drawing/2014/main" id="{47B1648B-2647-C79A-4DE2-D4013E596D19}"/>
                </a:ext>
              </a:extLst>
            </p:cNvPr>
            <p:cNvCxnSpPr>
              <a:cxnSpLocks/>
              <a:stCxn id="85" idx="2"/>
              <a:endCxn id="13" idx="0"/>
            </p:cNvCxnSpPr>
            <p:nvPr/>
          </p:nvCxnSpPr>
          <p:spPr>
            <a:xfrm flipH="1">
              <a:off x="7387738" y="2507931"/>
              <a:ext cx="1675" cy="84088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Arrow Connector 92">
              <a:extLst>
                <a:ext uri="{FF2B5EF4-FFF2-40B4-BE49-F238E27FC236}">
                  <a16:creationId xmlns:a16="http://schemas.microsoft.com/office/drawing/2014/main" id="{942A9B04-B6AC-6DC8-FE89-45C5896E7DEA}"/>
                </a:ext>
              </a:extLst>
            </p:cNvPr>
            <p:cNvCxnSpPr>
              <a:cxnSpLocks/>
              <a:endCxn id="94" idx="1"/>
            </p:cNvCxnSpPr>
            <p:nvPr/>
          </p:nvCxnSpPr>
          <p:spPr>
            <a:xfrm>
              <a:off x="7387738" y="2891653"/>
              <a:ext cx="705508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0351D455-F1E8-42BB-BC0E-6707B00D1290}"/>
                </a:ext>
              </a:extLst>
            </p:cNvPr>
            <p:cNvSpPr/>
            <p:nvPr/>
          </p:nvSpPr>
          <p:spPr>
            <a:xfrm>
              <a:off x="8093246" y="2623966"/>
              <a:ext cx="2939846" cy="5353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ed (n=61)</a:t>
              </a:r>
            </a:p>
            <a:p>
              <a:pPr marL="181166" indent="-181166">
                <a:buFont typeface="Arial" panose="020B0604020202020204" pitchFamily="34" charset="0"/>
                <a:buChar char="•"/>
              </a:pPr>
              <a:r>
                <a:rPr lang="en-US" sz="8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 documented imaging response (n=6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77262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00</TotalTime>
  <Words>240</Words>
  <Application>Microsoft Macintosh PowerPoint</Application>
  <PresentationFormat>Custom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hul Gupta</dc:creator>
  <cp:lastModifiedBy>Mehul Gupta</cp:lastModifiedBy>
  <cp:revision>63</cp:revision>
  <dcterms:created xsi:type="dcterms:W3CDTF">2022-09-22T20:35:09Z</dcterms:created>
  <dcterms:modified xsi:type="dcterms:W3CDTF">2024-02-12T17:38:53Z</dcterms:modified>
</cp:coreProperties>
</file>